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Geen stijl, tabel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90" d="100"/>
          <a:sy n="90" d="100"/>
        </p:scale>
        <p:origin x="35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ng-Bardelmeijer, AL de" userId="eac6435b-c1c8-4a83-8ad1-d541506c1f55" providerId="ADAL" clId="{0C01118F-F24A-488F-B3C0-60525AB5F65C}"/>
    <pc:docChg chg="modSld">
      <pc:chgData name="Jong-Bardelmeijer, AL de" userId="eac6435b-c1c8-4a83-8ad1-d541506c1f55" providerId="ADAL" clId="{0C01118F-F24A-488F-B3C0-60525AB5F65C}" dt="2025-07-23T12:40:50.568" v="1" actId="20577"/>
      <pc:docMkLst>
        <pc:docMk/>
      </pc:docMkLst>
      <pc:sldChg chg="modSp mod">
        <pc:chgData name="Jong-Bardelmeijer, AL de" userId="eac6435b-c1c8-4a83-8ad1-d541506c1f55" providerId="ADAL" clId="{0C01118F-F24A-488F-B3C0-60525AB5F65C}" dt="2025-07-23T12:40:50.568" v="1" actId="20577"/>
        <pc:sldMkLst>
          <pc:docMk/>
          <pc:sldMk cId="2818794904" sldId="256"/>
        </pc:sldMkLst>
        <pc:spChg chg="mod">
          <ac:chgData name="Jong-Bardelmeijer, AL de" userId="eac6435b-c1c8-4a83-8ad1-d541506c1f55" providerId="ADAL" clId="{0C01118F-F24A-488F-B3C0-60525AB5F65C}" dt="2025-07-23T12:40:50.568" v="1" actId="20577"/>
          <ac:spMkLst>
            <pc:docMk/>
            <pc:sldMk cId="2818794904" sldId="256"/>
            <ac:spMk id="5" creationId="{DDA3BF2A-10AE-177B-5974-081D54B7B5B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082B4E-CC09-DB46-A11C-9362915CF1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36013859-2952-308A-11F6-79D46EA9F5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DF80B2C-2BBA-D52B-1729-848FD2AEF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612C8270-4198-B2E0-2210-D8CB12D00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9EE55B43-8FAA-A11F-E828-4FD4543F3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5335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D1DBA92-DF8E-7D2E-E465-36AC81A77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3FD1EB5B-6404-32B6-5477-730D9D9020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376F1C2-3C6D-C6D0-B91A-08F6E5519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EE1F3663-10AC-A842-2FA9-60955692D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51B2B62D-E8A1-9BA5-2193-AD515A766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43285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AA927378-E060-C26A-5B40-CFB120A44E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E879E834-1ACE-A8E0-2211-27BEC5306C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EB64310-19AA-D13D-B33C-07D889280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24CAA73-52A5-F5D4-79C5-2756871E3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FA51D0C-728D-99C2-4227-2DE387EC4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97997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999C8D-E3DD-B608-7D6E-2F976E6A50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78688AF7-9F9F-3787-39CC-B5FCA26635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2ED5177-A6B2-F7E9-C659-5A4A8CE92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A2B3BF2-EE11-279C-8891-BB62A40B6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CB2F195-F580-B9F2-7995-CD069F469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34866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F9DF902-B3FE-2BF9-DF67-5D77C8BDA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BB24523A-91EE-A614-74A5-1B065C3EF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B6B49501-11A7-CCD9-2BC6-3E1DC4B31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943B227-1D83-86DD-84E6-FE067DA68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42E4F0B8-6AD9-F44D-0809-A47CA4F37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85495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B5DB046-5059-95E8-9448-E07F75A316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8C1E987-D341-A42F-9AC4-1914A7EAC0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B65A2C38-B555-BC04-78DE-051FF2FDC6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D371A011-D1D6-5C82-E8AD-C6A79CEAA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E420CA85-9F72-7BCE-0D01-8B7702584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47E7A40F-E138-DFDA-2095-D53723415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0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C4B9BD9-9F1A-A6ED-7018-79CFEBA6D3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0E782E56-3676-66AD-133E-3F47C064CB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F3C615F7-C6AC-0BDE-A1D7-F8EF17A468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8EDDFD8F-8825-24C3-557C-E5360049F6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C779EA7C-04BF-9732-A8FC-6EF8FCAF71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65AD115E-C666-C54A-5A32-8A94658D2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8528B1B8-A14C-5E63-C5A0-1EDB8E59B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77006971-70A3-1D2C-DEA5-41D36A052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31424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5855D8-9853-2F4E-179A-18C50235EA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F153E00B-4A28-9CE1-378D-B460AA6BD9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F181F1C6-648B-0472-1D6D-746098EC3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11D73652-B229-7864-DCF3-11129982E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40296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7F700424-BB93-B1BA-0FB0-24B146C38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AE9FDE50-86D0-EE63-3CFB-AE71CA3E0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709AB774-6672-BE69-7EC3-6206CB3D6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94441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C8E523-A300-5767-5835-9942E31282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CD5A643-7ABD-72C1-218F-5EBB944B60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6A416A82-72CB-AABE-6A14-4E3867880D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D1A1452C-E432-126E-4898-F714874FF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6CFCDC96-ADD7-6EF1-8599-0EBEE6842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4D652BBB-3440-BCDB-5690-39B58E66B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20285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5871081-E48C-588F-8FDE-028E4648D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E2DF1BD2-87E9-9F44-E136-9FEC178B1D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09F46B0C-E6F3-AE99-C076-CF3909F843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8977659B-A825-A3CA-668B-4DCFC2840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E7E01FD1-522F-B78B-16CB-EB935BC13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E024A95B-D52D-B591-8B68-F0483E18E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26519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B6D2707E-0D5E-36CD-299B-2A25E9984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8F163A3A-33BD-AD9E-1075-4C4756CA94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C7E9F3D-9768-25A6-0039-04F858E04B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5467CED-4247-589F-A328-08895D7B54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96B313B-B642-88BD-6CCC-6A9CA7B601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92839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>
            <a:extLst>
              <a:ext uri="{FF2B5EF4-FFF2-40B4-BE49-F238E27FC236}">
                <a16:creationId xmlns:a16="http://schemas.microsoft.com/office/drawing/2014/main" id="{DDA3BF2A-10AE-177B-5974-081D54B7B5BF}"/>
              </a:ext>
            </a:extLst>
          </p:cNvPr>
          <p:cNvSpPr txBox="1"/>
          <p:nvPr/>
        </p:nvSpPr>
        <p:spPr>
          <a:xfrm>
            <a:off x="397341" y="598358"/>
            <a:ext cx="8633012" cy="782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Bef>
                <a:spcPts val="1200"/>
              </a:spcBef>
            </a:pPr>
            <a:r>
              <a:rPr lang="en-GB" sz="1400" b="1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 Material</a:t>
            </a:r>
            <a:endParaRPr lang="nl-NL" sz="1400" b="1" kern="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r>
              <a:rPr lang="en-GB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nl-NL" sz="14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GB" sz="1400" b="1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able S3.</a:t>
            </a:r>
            <a:r>
              <a:rPr lang="en-GB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tribution of healthcare providers reported by respondents in the open text box</a:t>
            </a:r>
            <a:endParaRPr lang="nl-NL" sz="14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el 6">
            <a:extLst>
              <a:ext uri="{FF2B5EF4-FFF2-40B4-BE49-F238E27FC236}">
                <a16:creationId xmlns:a16="http://schemas.microsoft.com/office/drawing/2014/main" id="{7F1728C3-52FF-9976-6D5E-628D893385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9325679"/>
              </p:ext>
            </p:extLst>
          </p:nvPr>
        </p:nvGraphicFramePr>
        <p:xfrm>
          <a:off x="62753" y="2073120"/>
          <a:ext cx="11856423" cy="4324114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2178000">
                  <a:extLst>
                    <a:ext uri="{9D8B030D-6E8A-4147-A177-3AD203B41FA5}">
                      <a16:colId xmlns:a16="http://schemas.microsoft.com/office/drawing/2014/main" val="1469542632"/>
                    </a:ext>
                  </a:extLst>
                </a:gridCol>
                <a:gridCol w="882000">
                  <a:extLst>
                    <a:ext uri="{9D8B030D-6E8A-4147-A177-3AD203B41FA5}">
                      <a16:colId xmlns:a16="http://schemas.microsoft.com/office/drawing/2014/main" val="1303562543"/>
                    </a:ext>
                  </a:extLst>
                </a:gridCol>
                <a:gridCol w="1842000">
                  <a:extLst>
                    <a:ext uri="{9D8B030D-6E8A-4147-A177-3AD203B41FA5}">
                      <a16:colId xmlns:a16="http://schemas.microsoft.com/office/drawing/2014/main" val="320366320"/>
                    </a:ext>
                  </a:extLst>
                </a:gridCol>
                <a:gridCol w="882000">
                  <a:extLst>
                    <a:ext uri="{9D8B030D-6E8A-4147-A177-3AD203B41FA5}">
                      <a16:colId xmlns:a16="http://schemas.microsoft.com/office/drawing/2014/main" val="109935737"/>
                    </a:ext>
                  </a:extLst>
                </a:gridCol>
                <a:gridCol w="1950423">
                  <a:extLst>
                    <a:ext uri="{9D8B030D-6E8A-4147-A177-3AD203B41FA5}">
                      <a16:colId xmlns:a16="http://schemas.microsoft.com/office/drawing/2014/main" val="1650790708"/>
                    </a:ext>
                  </a:extLst>
                </a:gridCol>
                <a:gridCol w="882000">
                  <a:extLst>
                    <a:ext uri="{9D8B030D-6E8A-4147-A177-3AD203B41FA5}">
                      <a16:colId xmlns:a16="http://schemas.microsoft.com/office/drawing/2014/main" val="1549094568"/>
                    </a:ext>
                  </a:extLst>
                </a:gridCol>
                <a:gridCol w="2358000">
                  <a:extLst>
                    <a:ext uri="{9D8B030D-6E8A-4147-A177-3AD203B41FA5}">
                      <a16:colId xmlns:a16="http://schemas.microsoft.com/office/drawing/2014/main" val="2218988194"/>
                    </a:ext>
                  </a:extLst>
                </a:gridCol>
                <a:gridCol w="882000">
                  <a:extLst>
                    <a:ext uri="{9D8B030D-6E8A-4147-A177-3AD203B41FA5}">
                      <a16:colId xmlns:a16="http://schemas.microsoft.com/office/drawing/2014/main" val="2656617955"/>
                    </a:ext>
                  </a:extLst>
                </a:gridCol>
              </a:tblGrid>
              <a:tr h="15012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hospital specialists</a:t>
                      </a:r>
                      <a:endParaRPr lang="nl-NL" sz="10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respondents</a:t>
                      </a:r>
                      <a:endParaRPr lang="nl-NL" sz="10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healthcare providers </a:t>
                      </a:r>
                      <a:endParaRPr lang="nl-NL" sz="10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respondents</a:t>
                      </a:r>
                      <a:endParaRPr lang="nl-NL" sz="10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CAM healthcare providers</a:t>
                      </a:r>
                      <a:endParaRPr lang="nl-NL" sz="10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respondents</a:t>
                      </a:r>
                      <a:endParaRPr lang="nl-NL" sz="10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health providers/institutions </a:t>
                      </a:r>
                      <a:endParaRPr lang="nl-NL" sz="10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respondents</a:t>
                      </a:r>
                      <a:endParaRPr lang="nl-NL" sz="1000" b="1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8885076"/>
                  </a:ext>
                </a:extLst>
              </a:tr>
              <a:tr h="209162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n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ach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ot reflexolog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partum meetings pregnancy course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381165174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geon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tho manual therap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iatsu therap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hers cafe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1916011707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logist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ychosomatic therap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iki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ssage therap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2316824374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olo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ychomotor therap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-resonance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eep coach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3974295105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trointestinal special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therap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listic therap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esarean club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1593578975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n specialist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rth-trauma therap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olog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ula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812021539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lmonolo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s therap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dfulness trainer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rth trauma coach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3845578270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rmatolo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dfulness trainer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y-stress release practitioner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rmone coach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2705350464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 specialist 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ychosomatic physiotherapy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aniosacral therap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2061667735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thopaed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ycho dynamic therapist 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gral Pelvic Therapy (IPT)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3495809219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habilitation special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ychosocial therapist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thomolecular therap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445798083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olo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ditional Chinese medicine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1875205422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colo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iscop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2595205677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eumatologist  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um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4168168546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crinolo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ic therap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1934539125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tic Surgeon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3220791584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tolo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4029805146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olo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1858660693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rts physician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2291675105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er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1622007386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phrologist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3050309206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scular surgeon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821770807"/>
                  </a:ext>
                </a:extLst>
              </a:tr>
              <a:tr h="12372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surgeon </a:t>
                      </a: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/>
                </a:tc>
                <a:extLst>
                  <a:ext uri="{0D108BD9-81ED-4DB2-BD59-A6C34878D82A}">
                    <a16:rowId xmlns:a16="http://schemas.microsoft.com/office/drawing/2014/main" val="2805340177"/>
                  </a:ext>
                </a:extLst>
              </a:tr>
              <a:tr h="251918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uloskeletal Medicine physician 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endParaRPr lang="nl-NL" sz="10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429" marR="5942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81346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1879490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209</Words>
  <Application>Microsoft Office PowerPoint</Application>
  <PresentationFormat>Breedbeeld</PresentationFormat>
  <Paragraphs>127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nemarie Bardelmeijer</dc:creator>
  <cp:lastModifiedBy>Jong-Bardelmeijer, AL de</cp:lastModifiedBy>
  <cp:revision>3</cp:revision>
  <dcterms:created xsi:type="dcterms:W3CDTF">2024-10-23T10:03:12Z</dcterms:created>
  <dcterms:modified xsi:type="dcterms:W3CDTF">2025-07-23T12:40:52Z</dcterms:modified>
</cp:coreProperties>
</file>